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AF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844" y="-2392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/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9" name="Google Shape;99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/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95288" y="288328"/>
            <a:ext cx="9048581" cy="8337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800" b="1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formance of volume and diameter thresholds in malignancy prediction of solid nodules in lung cancer screening</a:t>
            </a:r>
            <a:endParaRPr lang="en-GB" sz="1800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6" name="Google Shape;106;p1"/>
          <p:cNvSpPr txBox="1"/>
          <p:nvPr/>
        </p:nvSpPr>
        <p:spPr>
          <a:xfrm>
            <a:off x="174793" y="1754015"/>
            <a:ext cx="2883521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3173752" y="1754015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lang="en-GB"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8" name="Google Shape;108;p1"/>
          <p:cNvSpPr txBox="1"/>
          <p:nvPr/>
        </p:nvSpPr>
        <p:spPr>
          <a:xfrm>
            <a:off x="6172710" y="1719742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A391E63-A225-E337-9B4F-6807C966A877}"/>
              </a:ext>
            </a:extLst>
          </p:cNvPr>
          <p:cNvSpPr txBox="1"/>
          <p:nvPr/>
        </p:nvSpPr>
        <p:spPr>
          <a:xfrm>
            <a:off x="500062" y="988889"/>
            <a:ext cx="8585201" cy="2654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W Creamer et al  Thora</a:t>
            </a:r>
            <a:r>
              <a:rPr lang="en-GB" sz="1100" b="1" kern="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</a:t>
            </a:r>
            <a:r>
              <a:rPr lang="en-GB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025. DOI 10.1136/thorax-2025-222086</a:t>
            </a:r>
            <a:endParaRPr lang="en-GB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Google Shape;104;p1">
            <a:extLst>
              <a:ext uri="{FF2B5EF4-FFF2-40B4-BE49-F238E27FC236}">
                <a16:creationId xmlns:a16="http://schemas.microsoft.com/office/drawing/2014/main" id="{4BA783B9-A3C8-09B3-3B3B-30924A9FB695}"/>
              </a:ext>
            </a:extLst>
          </p:cNvPr>
          <p:cNvSpPr/>
          <p:nvPr/>
        </p:nvSpPr>
        <p:spPr>
          <a:xfrm>
            <a:off x="174794" y="1762407"/>
            <a:ext cx="2808368" cy="229571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" name="Google Shape;104;p1">
            <a:extLst>
              <a:ext uri="{FF2B5EF4-FFF2-40B4-BE49-F238E27FC236}">
                <a16:creationId xmlns:a16="http://schemas.microsoft.com/office/drawing/2014/main" id="{EB630248-8902-DCD5-A30B-F2D57E0E3D6B}"/>
              </a:ext>
            </a:extLst>
          </p:cNvPr>
          <p:cNvSpPr/>
          <p:nvPr/>
        </p:nvSpPr>
        <p:spPr>
          <a:xfrm>
            <a:off x="6160838" y="4231538"/>
            <a:ext cx="2808368" cy="202912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2" name="Picture 11" descr="A flowchart of a patient's flow&#10;&#10;AI-generated content may be incorrect.">
            <a:extLst>
              <a:ext uri="{FF2B5EF4-FFF2-40B4-BE49-F238E27FC236}">
                <a16:creationId xmlns:a16="http://schemas.microsoft.com/office/drawing/2014/main" id="{272C4B66-BBA3-34D6-72E7-912CDC2207C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04278" y="1794599"/>
            <a:ext cx="2692415" cy="2420760"/>
          </a:xfrm>
          <a:prstGeom prst="rect">
            <a:avLst/>
          </a:prstGeom>
        </p:spPr>
      </p:pic>
      <p:sp>
        <p:nvSpPr>
          <p:cNvPr id="13" name="Google Shape;105;p1">
            <a:extLst>
              <a:ext uri="{FF2B5EF4-FFF2-40B4-BE49-F238E27FC236}">
                <a16:creationId xmlns:a16="http://schemas.microsoft.com/office/drawing/2014/main" id="{56936E37-ECA4-E35F-796E-8741F94C75C2}"/>
              </a:ext>
            </a:extLst>
          </p:cNvPr>
          <p:cNvSpPr txBox="1"/>
          <p:nvPr/>
        </p:nvSpPr>
        <p:spPr>
          <a:xfrm>
            <a:off x="6750394" y="4148710"/>
            <a:ext cx="1633475" cy="4715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b="1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ke home:</a:t>
            </a:r>
            <a:endParaRPr lang="en-GB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Google Shape;105;p1">
            <a:extLst>
              <a:ext uri="{FF2B5EF4-FFF2-40B4-BE49-F238E27FC236}">
                <a16:creationId xmlns:a16="http://schemas.microsoft.com/office/drawing/2014/main" id="{DA1CB370-8D8B-98F7-1440-4FEFCE5FC7AF}"/>
              </a:ext>
            </a:extLst>
          </p:cNvPr>
          <p:cNvSpPr txBox="1"/>
          <p:nvPr/>
        </p:nvSpPr>
        <p:spPr>
          <a:xfrm>
            <a:off x="762241" y="1682278"/>
            <a:ext cx="1633475" cy="4715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b="1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hods:</a:t>
            </a:r>
            <a:endParaRPr lang="en-GB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530CE2F3-8820-6FC9-1A94-424E4BA80D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0078776"/>
              </p:ext>
            </p:extLst>
          </p:nvPr>
        </p:nvGraphicFramePr>
        <p:xfrm>
          <a:off x="283130" y="3734015"/>
          <a:ext cx="2632306" cy="1656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85261">
                  <a:extLst>
                    <a:ext uri="{9D8B030D-6E8A-4147-A177-3AD203B41FA5}">
                      <a16:colId xmlns:a16="http://schemas.microsoft.com/office/drawing/2014/main" val="969269871"/>
                    </a:ext>
                  </a:extLst>
                </a:gridCol>
                <a:gridCol w="487485">
                  <a:extLst>
                    <a:ext uri="{9D8B030D-6E8A-4147-A177-3AD203B41FA5}">
                      <a16:colId xmlns:a16="http://schemas.microsoft.com/office/drawing/2014/main" val="4031902734"/>
                    </a:ext>
                  </a:extLst>
                </a:gridCol>
                <a:gridCol w="474133">
                  <a:extLst>
                    <a:ext uri="{9D8B030D-6E8A-4147-A177-3AD203B41FA5}">
                      <a16:colId xmlns:a16="http://schemas.microsoft.com/office/drawing/2014/main" val="2760196142"/>
                    </a:ext>
                  </a:extLst>
                </a:gridCol>
                <a:gridCol w="524934">
                  <a:extLst>
                    <a:ext uri="{9D8B030D-6E8A-4147-A177-3AD203B41FA5}">
                      <a16:colId xmlns:a16="http://schemas.microsoft.com/office/drawing/2014/main" val="1527067134"/>
                    </a:ext>
                  </a:extLst>
                </a:gridCol>
                <a:gridCol w="560493">
                  <a:extLst>
                    <a:ext uri="{9D8B030D-6E8A-4147-A177-3AD203B41FA5}">
                      <a16:colId xmlns:a16="http://schemas.microsoft.com/office/drawing/2014/main" val="1224664986"/>
                    </a:ext>
                  </a:extLst>
                </a:gridCol>
              </a:tblGrid>
              <a:tr h="38383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550" kern="0" dirty="0">
                          <a:effectLst/>
                        </a:rPr>
                        <a:t>Threshold</a:t>
                      </a:r>
                      <a:endParaRPr lang="en-GB" sz="55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 dirty="0">
                          <a:effectLst/>
                        </a:rPr>
                        <a:t>Cancers/</a:t>
                      </a:r>
                      <a:endParaRPr lang="en-GB" sz="55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 dirty="0">
                          <a:effectLst/>
                        </a:rPr>
                        <a:t>participants</a:t>
                      </a:r>
                      <a:endParaRPr lang="en-GB" sz="55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>
                          <a:effectLst/>
                        </a:rPr>
                        <a:t>Sensitivity</a:t>
                      </a:r>
                      <a:endParaRPr lang="en-GB" sz="55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>
                          <a:effectLst/>
                        </a:rPr>
                        <a:t>(95% CI)</a:t>
                      </a:r>
                      <a:endParaRPr lang="en-GB" sz="55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 dirty="0">
                          <a:effectLst/>
                        </a:rPr>
                        <a:t>Specificity</a:t>
                      </a:r>
                      <a:endParaRPr lang="en-GB" sz="55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 dirty="0">
                          <a:effectLst/>
                        </a:rPr>
                        <a:t>(95% CI)</a:t>
                      </a:r>
                      <a:endParaRPr lang="en-GB" sz="55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 dirty="0">
                          <a:effectLst/>
                        </a:rPr>
                        <a:t>Negative predictive value</a:t>
                      </a:r>
                      <a:endParaRPr lang="en-GB" sz="55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550" kern="0" dirty="0">
                          <a:effectLst/>
                        </a:rPr>
                        <a:t>(95% CI)</a:t>
                      </a:r>
                      <a:endParaRPr lang="en-GB" sz="55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5866094"/>
                  </a:ext>
                </a:extLst>
              </a:tr>
              <a:tr h="22144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No nodules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37/4809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 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effectLst/>
                        </a:rPr>
                        <a:t> 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effectLst/>
                        </a:rPr>
                        <a:t> 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5731795"/>
                  </a:ext>
                </a:extLst>
              </a:tr>
              <a:tr h="1959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Any solid nodule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228/5929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-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effectLst/>
                        </a:rPr>
                        <a:t>-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effectLst/>
                        </a:rPr>
                        <a:t>-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3059272"/>
                  </a:ext>
                </a:extLst>
              </a:tr>
              <a:tr h="22169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&lt;5mm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effectLst/>
                        </a:rPr>
                        <a:t>15/1421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93.4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89.4-96.3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24.6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23.5-25.8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98.9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98.3-99.4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8551583"/>
                  </a:ext>
                </a:extLst>
              </a:tr>
              <a:tr h="21430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&lt;6mm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21/2378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90.8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86.3-94.2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41.3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40.1-42.6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99.1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98.7-99.5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5514051"/>
                  </a:ext>
                </a:extLst>
              </a:tr>
              <a:tr h="2085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&lt;80mm</a:t>
                      </a:r>
                      <a:r>
                        <a:rPr lang="en-GB" sz="600" kern="0" baseline="30000" dirty="0">
                          <a:effectLst/>
                        </a:rPr>
                        <a:t>3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effectLst/>
                        </a:rPr>
                        <a:t>30/3756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86.8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81.8-90.9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65.4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64.1-66.7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99.2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98.9-99.5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2393457"/>
                  </a:ext>
                </a:extLst>
              </a:tr>
              <a:tr h="2101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&lt;100mm</a:t>
                      </a:r>
                      <a:r>
                        <a:rPr lang="en-GB" sz="600" kern="0" baseline="30000" dirty="0">
                          <a:effectLst/>
                        </a:rPr>
                        <a:t>3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effectLst/>
                        </a:rPr>
                        <a:t>34/4183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85.1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79.8-89.4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72.8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71.6-73.9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99.2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98.9-99.4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760" marR="4076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1606987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38152D03-49EF-85FF-CC02-07B5F7D0A1D8}"/>
              </a:ext>
            </a:extLst>
          </p:cNvPr>
          <p:cNvSpPr txBox="1"/>
          <p:nvPr/>
        </p:nvSpPr>
        <p:spPr>
          <a:xfrm>
            <a:off x="105736" y="2067121"/>
            <a:ext cx="300267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Clr>
                <a:srgbClr val="3399FF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bservational study using data from the SUMMIT study</a:t>
            </a:r>
          </a:p>
          <a:p>
            <a:pPr marL="171450" indent="-171450">
              <a:buClr>
                <a:srgbClr val="3399FF"/>
              </a:buClr>
              <a:buFont typeface="Arial" panose="020B0604020202020204" pitchFamily="34" charset="0"/>
              <a:buChar char="•"/>
            </a:pPr>
            <a:r>
              <a:rPr lang="en-US" sz="1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DCTs were reported using </a:t>
            </a:r>
            <a:r>
              <a:rPr lang="en-US" sz="1000" dirty="0" err="1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ADe</a:t>
            </a:r>
            <a:r>
              <a:rPr lang="en-US" sz="1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oftware (</a:t>
            </a:r>
            <a:r>
              <a:rPr lang="en-US" sz="1000" dirty="0" err="1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Veolity</a:t>
            </a:r>
            <a:r>
              <a:rPr lang="en-US" sz="1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eVIS</a:t>
            </a:r>
            <a:r>
              <a:rPr lang="en-US" sz="1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with semi-automated volumetry</a:t>
            </a:r>
          </a:p>
          <a:p>
            <a:pPr marL="171450" indent="-171450">
              <a:buClr>
                <a:srgbClr val="3399FF"/>
              </a:buClr>
              <a:buFont typeface="Arial" panose="020B0604020202020204" pitchFamily="34" charset="0"/>
              <a:buChar char="•"/>
            </a:pPr>
            <a:r>
              <a:rPr lang="en-US" sz="1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alignancy risk stratified by pre-defined size thresholds: </a:t>
            </a:r>
          </a:p>
          <a:p>
            <a:pPr marL="252000" lvl="3" indent="-171450">
              <a:buClr>
                <a:srgbClr val="3399FF"/>
              </a:buClr>
              <a:buFont typeface="Arial" panose="020B0604020202020204" pitchFamily="34" charset="0"/>
              <a:buChar char="•"/>
            </a:pPr>
            <a:r>
              <a:rPr lang="en-US" sz="95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5/6mm long axis diameter or 80/100mm</a:t>
            </a:r>
            <a:r>
              <a:rPr lang="en-US" sz="950" baseline="30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</a:t>
            </a:r>
            <a:r>
              <a:rPr lang="en-US" sz="95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olume “rule out” thresholds for low-risk nodules </a:t>
            </a:r>
          </a:p>
          <a:p>
            <a:pPr marL="252000" indent="-171450">
              <a:buClr>
                <a:srgbClr val="3399FF"/>
              </a:buClr>
              <a:buFont typeface="Arial" panose="020B0604020202020204" pitchFamily="34" charset="0"/>
              <a:buChar char="•"/>
            </a:pPr>
            <a:r>
              <a:rPr lang="en-US" sz="95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≥300mm</a:t>
            </a:r>
            <a:r>
              <a:rPr lang="en-US" sz="950" baseline="30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</a:t>
            </a:r>
            <a:r>
              <a:rPr lang="en-US" sz="95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r ≥8mm diameter +/- Brock ≥10% “rule in” thresholds for high-risk nodules</a:t>
            </a:r>
            <a:endParaRPr lang="en-GB" sz="95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graph of a function&#10;&#10;AI-generated content may be incorrect.">
            <a:extLst>
              <a:ext uri="{FF2B5EF4-FFF2-40B4-BE49-F238E27FC236}">
                <a16:creationId xmlns:a16="http://schemas.microsoft.com/office/drawing/2014/main" id="{103371DE-EEC1-0B1F-CB85-71BE35CA327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55714" y="4255853"/>
            <a:ext cx="1466026" cy="141766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752C850-8199-5A4C-B310-BE04082159E2}"/>
              </a:ext>
            </a:extLst>
          </p:cNvPr>
          <p:cNvSpPr txBox="1"/>
          <p:nvPr/>
        </p:nvSpPr>
        <p:spPr>
          <a:xfrm>
            <a:off x="6260224" y="4409817"/>
            <a:ext cx="267126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Clr>
                <a:srgbClr val="00AFF0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olid nodules &lt;100mm</a:t>
            </a:r>
            <a:r>
              <a:rPr lang="en-GB" sz="1000" baseline="30000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000" dirty="0"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GB" sz="1000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&lt;6mm diameter were not </a:t>
            </a:r>
            <a:r>
              <a:rPr lang="en-GB" sz="100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ociated with ↑ </a:t>
            </a:r>
            <a:r>
              <a:rPr lang="en-GB" sz="1000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sk of lung cancer </a:t>
            </a:r>
            <a:r>
              <a:rPr lang="en-GB" sz="1000" i="1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GB" sz="1000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rticipants with no nodules</a:t>
            </a:r>
          </a:p>
          <a:p>
            <a:pPr marL="171450" indent="-171450">
              <a:buClr>
                <a:srgbClr val="00AFF0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olumetric rule-out thresholds achieve equivalent NPV to long-axis diameter thresholds whilst encompassing significantly more participants = </a:t>
            </a:r>
            <a:r>
              <a:rPr lang="en-GB" sz="1000" b="1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↓</a:t>
            </a:r>
            <a:r>
              <a:rPr lang="en-GB" sz="1000" dirty="0"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terval scans and </a:t>
            </a:r>
            <a:r>
              <a:rPr lang="en-GB" sz="1000" b="1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↓ </a:t>
            </a:r>
            <a:r>
              <a:rPr lang="en-GB" sz="1000" dirty="0">
                <a:solidFill>
                  <a:schemeClr val="tx1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lse-positive MDT referrals</a:t>
            </a:r>
            <a:endParaRPr lang="en-GB" sz="1000" dirty="0">
              <a:solidFill>
                <a:schemeClr val="tx1"/>
              </a:solidFill>
              <a:latin typeface="Aptos" panose="020B00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4D46361-09B5-30F6-9F0A-13A16AC09A60}"/>
              </a:ext>
            </a:extLst>
          </p:cNvPr>
          <p:cNvSpPr txBox="1"/>
          <p:nvPr/>
        </p:nvSpPr>
        <p:spPr>
          <a:xfrm>
            <a:off x="4699848" y="4801520"/>
            <a:ext cx="1357425" cy="95410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700" b="1" kern="100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OC curves for nodule diameter and volume. </a:t>
            </a:r>
          </a:p>
          <a:p>
            <a:r>
              <a:rPr lang="en-GB" sz="700" kern="100" dirty="0">
                <a:solidFill>
                  <a:srgbClr val="00AFF0"/>
                </a:solidFill>
                <a:latin typeface="Aptos" panose="020B00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UC </a:t>
            </a:r>
            <a:r>
              <a:rPr lang="en-GB" sz="700" kern="100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 diameter 0.822 (95%CI 0.787-0.857) vs volume 0.844 (95%CI 0.807-0.8820), p=0.3852</a:t>
            </a:r>
            <a:endParaRPr lang="en-GB" sz="700" kern="100" dirty="0">
              <a:solidFill>
                <a:srgbClr val="00AFF0"/>
              </a:solidFill>
              <a:effectLst/>
              <a:latin typeface="Aptos" panose="020B00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8830896-6C19-EA43-74A1-E7EE53EC8532}"/>
              </a:ext>
            </a:extLst>
          </p:cNvPr>
          <p:cNvSpPr txBox="1"/>
          <p:nvPr/>
        </p:nvSpPr>
        <p:spPr>
          <a:xfrm>
            <a:off x="5058741" y="1969487"/>
            <a:ext cx="999946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700" b="1" kern="100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NSORT Diagram</a:t>
            </a:r>
            <a:endParaRPr lang="en-GB" sz="700" kern="100" dirty="0">
              <a:solidFill>
                <a:srgbClr val="00AFF0"/>
              </a:solidFill>
              <a:effectLst/>
              <a:latin typeface="Aptos" panose="020B00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3162D63-F40D-E308-CA95-E997B287D890}"/>
              </a:ext>
            </a:extLst>
          </p:cNvPr>
          <p:cNvSpPr txBox="1"/>
          <p:nvPr/>
        </p:nvSpPr>
        <p:spPr>
          <a:xfrm>
            <a:off x="236990" y="5402978"/>
            <a:ext cx="2683976" cy="35125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 kern="100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formance of rule-out diameter and volume thresholds for solid non-calcified nodules at baseline LDCT</a:t>
            </a:r>
          </a:p>
        </p:txBody>
      </p:sp>
      <p:sp>
        <p:nvSpPr>
          <p:cNvPr id="21" name="Google Shape;104;p1">
            <a:extLst>
              <a:ext uri="{FF2B5EF4-FFF2-40B4-BE49-F238E27FC236}">
                <a16:creationId xmlns:a16="http://schemas.microsoft.com/office/drawing/2014/main" id="{B178B4A3-3FCA-4B1B-5C4C-F5E6D61CE343}"/>
              </a:ext>
            </a:extLst>
          </p:cNvPr>
          <p:cNvSpPr/>
          <p:nvPr/>
        </p:nvSpPr>
        <p:spPr>
          <a:xfrm>
            <a:off x="171079" y="1275025"/>
            <a:ext cx="8809999" cy="425366"/>
          </a:xfrm>
          <a:prstGeom prst="rect">
            <a:avLst/>
          </a:prstGeom>
          <a:solidFill>
            <a:schemeClr val="bg1"/>
          </a:solidFill>
          <a:ln w="38100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>
              <a:buClr>
                <a:srgbClr val="3399FF"/>
              </a:buClr>
            </a:pPr>
            <a:r>
              <a:rPr lang="en-GB" b="1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im: </a:t>
            </a:r>
            <a:r>
              <a:rPr lang="en-GB" sz="1050" dirty="0">
                <a:solidFill>
                  <a:schemeClr val="tx1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amine the performance of size and risk thresholds for assessing malignancy in solid nodules at baseline low-dose CT in a lung cancer screening (LCS) programme.</a:t>
            </a:r>
            <a:endParaRPr lang="en-GB" sz="900" dirty="0">
              <a:solidFill>
                <a:schemeClr val="tx1"/>
              </a:solidFill>
            </a:endParaRPr>
          </a:p>
        </p:txBody>
      </p:sp>
      <p:graphicFrame>
        <p:nvGraphicFramePr>
          <p:cNvPr id="22" name="Table 21">
            <a:extLst>
              <a:ext uri="{FF2B5EF4-FFF2-40B4-BE49-F238E27FC236}">
                <a16:creationId xmlns:a16="http://schemas.microsoft.com/office/drawing/2014/main" id="{8915040A-A44C-2869-159D-772C76E273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8752517"/>
              </p:ext>
            </p:extLst>
          </p:nvPr>
        </p:nvGraphicFramePr>
        <p:xfrm>
          <a:off x="6042025" y="1718932"/>
          <a:ext cx="3043238" cy="2207695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125601">
                  <a:extLst>
                    <a:ext uri="{9D8B030D-6E8A-4147-A177-3AD203B41FA5}">
                      <a16:colId xmlns:a16="http://schemas.microsoft.com/office/drawing/2014/main" val="3042114403"/>
                    </a:ext>
                  </a:extLst>
                </a:gridCol>
                <a:gridCol w="752660">
                  <a:extLst>
                    <a:ext uri="{9D8B030D-6E8A-4147-A177-3AD203B41FA5}">
                      <a16:colId xmlns:a16="http://schemas.microsoft.com/office/drawing/2014/main" val="834622737"/>
                    </a:ext>
                  </a:extLst>
                </a:gridCol>
                <a:gridCol w="745780">
                  <a:extLst>
                    <a:ext uri="{9D8B030D-6E8A-4147-A177-3AD203B41FA5}">
                      <a16:colId xmlns:a16="http://schemas.microsoft.com/office/drawing/2014/main" val="3182646363"/>
                    </a:ext>
                  </a:extLst>
                </a:gridCol>
                <a:gridCol w="419197">
                  <a:extLst>
                    <a:ext uri="{9D8B030D-6E8A-4147-A177-3AD203B41FA5}">
                      <a16:colId xmlns:a16="http://schemas.microsoft.com/office/drawing/2014/main" val="931043564"/>
                    </a:ext>
                  </a:extLst>
                </a:gridCol>
              </a:tblGrid>
              <a:tr h="17162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solidFill>
                            <a:schemeClr val="bg1"/>
                          </a:solidFill>
                          <a:effectLst/>
                        </a:rPr>
                        <a:t>“Rule in” size threshold alone</a:t>
                      </a:r>
                      <a:endParaRPr lang="en-GB" sz="600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≥8mm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≥300mm</a:t>
                      </a:r>
                      <a:r>
                        <a:rPr lang="en-GB" sz="600" b="1" kern="0" baseline="30000" dirty="0">
                          <a:solidFill>
                            <a:schemeClr val="bg1"/>
                          </a:solidFill>
                          <a:effectLst/>
                        </a:rPr>
                        <a:t>3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P value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766608"/>
                  </a:ext>
                </a:extLst>
              </a:tr>
              <a:tr h="1727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500" kern="0" dirty="0">
                          <a:solidFill>
                            <a:schemeClr val="bg1"/>
                          </a:solidFill>
                          <a:effectLst/>
                        </a:rPr>
                        <a:t>Cancers/All participants with nodule meeting threshold</a:t>
                      </a:r>
                      <a:endParaRPr lang="en-GB" sz="500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177/1855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152/511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 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1032624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solidFill>
                            <a:schemeClr val="bg1"/>
                          </a:solidFill>
                          <a:effectLst/>
                        </a:rPr>
                        <a:t>Sensitivity</a:t>
                      </a:r>
                      <a:endParaRPr lang="en-GB" sz="600" kern="10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77.6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71.7-82.9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66.7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60.1-72.8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&lt;0.0001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114007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solidFill>
                            <a:schemeClr val="bg1"/>
                          </a:solidFill>
                          <a:effectLst/>
                        </a:rPr>
                        <a:t>Specificity</a:t>
                      </a:r>
                      <a:endParaRPr lang="en-GB" sz="600" kern="10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70.6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69.4-71.7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93.7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93.0-94.3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&lt;0.0001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9950272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solidFill>
                            <a:schemeClr val="bg1"/>
                          </a:solidFill>
                          <a:effectLst/>
                        </a:rPr>
                        <a:t>Positive predictive value</a:t>
                      </a:r>
                      <a:endParaRPr lang="en-GB" sz="600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9.5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8.2-11.0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29.7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25.8-33.9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-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5494345"/>
                  </a:ext>
                </a:extLst>
              </a:tr>
              <a:tr h="2210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b="0" kern="0" dirty="0">
                          <a:solidFill>
                            <a:schemeClr val="bg1"/>
                          </a:solidFill>
                          <a:effectLst/>
                        </a:rPr>
                        <a:t>“Rule in” size threshold and Brock risk model ≥10%</a:t>
                      </a:r>
                      <a:endParaRPr lang="en-GB" sz="600" b="0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≥8mm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and Brock ≥10%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≥300mm</a:t>
                      </a:r>
                      <a:r>
                        <a:rPr lang="en-GB" sz="600" b="1" kern="0" baseline="30000" dirty="0">
                          <a:solidFill>
                            <a:schemeClr val="bg1"/>
                          </a:solidFill>
                          <a:effectLst/>
                        </a:rPr>
                        <a:t>3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and Brock ≥10%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kern="0" dirty="0">
                          <a:solidFill>
                            <a:schemeClr val="bg1"/>
                          </a:solidFill>
                          <a:effectLst/>
                        </a:rPr>
                        <a:t> </a:t>
                      </a:r>
                      <a:endParaRPr lang="en-GB" sz="600" b="1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7517856"/>
                  </a:ext>
                </a:extLst>
              </a:tr>
              <a:tr h="1819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500" kern="0" dirty="0">
                          <a:solidFill>
                            <a:schemeClr val="bg1"/>
                          </a:solidFill>
                          <a:effectLst/>
                        </a:rPr>
                        <a:t>Cancers/All participants with nodule meeting threshold</a:t>
                      </a:r>
                      <a:endParaRPr lang="en-GB" sz="500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149/479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139/337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 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1694649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>
                          <a:solidFill>
                            <a:schemeClr val="bg1"/>
                          </a:solidFill>
                          <a:effectLst/>
                        </a:rPr>
                        <a:t>Sensitivity</a:t>
                      </a:r>
                      <a:endParaRPr lang="en-GB" sz="600" kern="10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65.4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58.8-71.5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60.9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54.3-67.3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0.0044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1910840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solidFill>
                            <a:schemeClr val="bg1"/>
                          </a:solidFill>
                          <a:effectLst/>
                        </a:rPr>
                        <a:t>Specificity</a:t>
                      </a:r>
                      <a:endParaRPr lang="en-GB" sz="600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94.2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93.6-94.8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96.5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96.0-97.0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&lt;0.0001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9494314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600" kern="0" dirty="0">
                          <a:solidFill>
                            <a:schemeClr val="bg1"/>
                          </a:solidFill>
                          <a:effectLst/>
                        </a:rPr>
                        <a:t>Positive predictive value</a:t>
                      </a:r>
                      <a:endParaRPr lang="en-GB" sz="600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AF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31.1%</a:t>
                      </a:r>
                      <a:endParaRPr lang="en-GB" sz="600" kern="1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(27.0-35.5)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41.2%</a:t>
                      </a:r>
                      <a:endParaRPr lang="en-GB" sz="6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>
                          <a:effectLst/>
                        </a:rPr>
                        <a:t>(35.9-46.7)</a:t>
                      </a:r>
                      <a:endParaRPr lang="en-GB" sz="6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kern="0" dirty="0">
                          <a:effectLst/>
                        </a:rPr>
                        <a:t>-</a:t>
                      </a:r>
                      <a:endParaRPr lang="en-GB" sz="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AFF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9613332"/>
                  </a:ext>
                </a:extLst>
              </a:tr>
            </a:tbl>
          </a:graphicData>
        </a:graphic>
      </p:graphicFrame>
      <p:sp>
        <p:nvSpPr>
          <p:cNvPr id="23" name="TextBox 22">
            <a:extLst>
              <a:ext uri="{FF2B5EF4-FFF2-40B4-BE49-F238E27FC236}">
                <a16:creationId xmlns:a16="http://schemas.microsoft.com/office/drawing/2014/main" id="{2ED27CEB-D517-0C1A-CB70-B6F902192FF3}"/>
              </a:ext>
            </a:extLst>
          </p:cNvPr>
          <p:cNvSpPr txBox="1"/>
          <p:nvPr/>
        </p:nvSpPr>
        <p:spPr>
          <a:xfrm>
            <a:off x="6253866" y="3912503"/>
            <a:ext cx="2683976" cy="35125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 kern="100" dirty="0">
                <a:solidFill>
                  <a:srgbClr val="00AFF0"/>
                </a:solidFill>
                <a:effectLst/>
                <a:latin typeface="Aptos" panose="020B00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formance of rule-in diameter and volume thresholds for solid non-calcified nodules at baseline LDCT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516</Words>
  <Application>Microsoft Office PowerPoint</Application>
  <PresentationFormat>On-screen Show (4:3)</PresentationFormat>
  <Paragraphs>1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olantonio</dc:creator>
  <cp:lastModifiedBy>Creamer, Andrew</cp:lastModifiedBy>
  <cp:revision>18</cp:revision>
  <dcterms:created xsi:type="dcterms:W3CDTF">2018-02-16T17:34:16Z</dcterms:created>
  <dcterms:modified xsi:type="dcterms:W3CDTF">2025-03-15T19:06:52Z</dcterms:modified>
</cp:coreProperties>
</file>